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notesMasterIdLst>
    <p:notesMasterId r:id="rId12"/>
  </p:notesMasterIdLst>
  <p:sldIdLst>
    <p:sldId id="274" r:id="rId3"/>
    <p:sldId id="256" r:id="rId4"/>
    <p:sldId id="272" r:id="rId5"/>
    <p:sldId id="271" r:id="rId6"/>
    <p:sldId id="266" r:id="rId7"/>
    <p:sldId id="265" r:id="rId8"/>
    <p:sldId id="269" r:id="rId9"/>
    <p:sldId id="270" r:id="rId10"/>
    <p:sldId id="273" r:id="rId11"/>
  </p:sldIdLst>
  <p:sldSz cx="6400800" cy="8229600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303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A02D00-B47C-4441-80C8-67A74A63AC1F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6988" y="1257300"/>
            <a:ext cx="2638425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33BE2-9F81-4026-B269-58B65FD6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084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033BE2-9F81-4026-B269-58B65FD6233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6208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6F6F7030-2A2D-44A8-A5A9-2A02B37F5714}" type="slidenum">
              <a:t>‹#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552024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39920" y="4917600"/>
            <a:ext cx="552024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A1E15CA6-16F1-4113-AD1F-D90BE75BF06C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3992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6844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4744EDC1-0935-4269-A315-E8879416A9FE}" type="slidenum">
              <a:t>‹#›</a:t>
            </a:fld>
            <a:endParaRPr/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306520" y="2190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120" y="2190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39920" y="4917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306520" y="4917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120" y="4917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66D63A37-5BBD-45E6-B0DB-1FD900F85194}" type="slidenum">
              <a:t>‹#›</a:t>
            </a:fld>
            <a:endParaRPr/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A80D8CA1-8ADC-4D64-A3C8-7593CE3FB6A5}" type="slidenum">
              <a:t>‹#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39920" y="2190600"/>
            <a:ext cx="552024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12313360-785C-480B-BEA8-1C5EBDE37988}" type="slidenum">
              <a:t>‹#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552024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466FA350-4BC4-46AC-BDA8-8F1E237697B2}" type="slidenum">
              <a:t>‹#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D7055BED-5679-4D9F-8EA7-100FB20F9FC5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1AAB5CE1-47E0-472A-8619-319DEB3FA38C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39920" y="438120"/>
            <a:ext cx="5520240" cy="7373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CA424C60-3966-4FAF-9909-7A358E4663CA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3992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CA90880E-E2F1-4B02-A9D2-C4B6A16A3E73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39920" y="2190600"/>
            <a:ext cx="552024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2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8E0B6AD4-7172-4479-BF30-F7205B34F32F}" type="slidenum">
              <a:t>‹#›</a:t>
            </a:fld>
            <a:endParaRPr/>
          </a:p>
        </p:txBody>
      </p:sp>
      <p:sp>
        <p:nvSpPr>
          <p:cNvPr id="3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26844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85E3007C-41C2-41DF-A0D7-05DB2608459F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39920" y="4917600"/>
            <a:ext cx="552024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C265F04A-817B-477D-8606-99F9E272FAFB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552024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39920" y="4917600"/>
            <a:ext cx="552024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76E727CE-ACE2-4616-AC39-32C0793F6C4E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3992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26844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E8EB838F-181F-444D-9C3D-803E1174476F}" type="slidenum">
              <a:t>‹#›</a:t>
            </a:fld>
            <a:endParaRPr/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306520" y="2190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173120" y="2190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39920" y="4917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306520" y="4917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173120" y="4917600"/>
            <a:ext cx="17773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B2FE18F7-41B3-44A8-93DF-DC30CA0A2D40}" type="slidenum">
              <a:t>‹#›</a:t>
            </a:fld>
            <a:endParaRPr/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552024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31DCC6EC-61F0-4375-82B7-7643993C839A}" type="slidenum">
              <a:t>‹#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96BC9BDC-5998-456C-A3DC-2513A97462E1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A538206D-55E6-489B-B521-8099705606C9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39920" y="438120"/>
            <a:ext cx="5520240" cy="7373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4482C75F-D714-4191-B3F6-14B4F88F3DA5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3992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704E5C76-79A8-4D45-9C25-5979B75A3424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52210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68440" y="4917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8683F170-5F37-43AD-B5DE-FDD776EE4657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3992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68440" y="2190600"/>
            <a:ext cx="269352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39920" y="4917600"/>
            <a:ext cx="5520240" cy="2490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196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C139D8B3-255D-46AA-8777-74151BC8D2DB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80240" y="1346760"/>
            <a:ext cx="5440320" cy="28648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algn="ctr">
              <a:lnSpc>
                <a:spcPct val="90000"/>
              </a:lnSpc>
              <a:buNone/>
            </a:pPr>
            <a:r>
              <a:rPr lang="en-US" sz="4200" b="0" strike="noStrike" spc="-1">
                <a:solidFill>
                  <a:srgbClr val="000000"/>
                </a:solidFill>
                <a:latin typeface="Calibri Light"/>
              </a:rPr>
              <a:t>Click to edit Master title style</a:t>
            </a:r>
            <a:endParaRPr lang="en-US" sz="4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dt" idx="1"/>
          </p:nvPr>
        </p:nvSpPr>
        <p:spPr>
          <a:xfrm>
            <a:off x="439920" y="7627680"/>
            <a:ext cx="1440000" cy="437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>
              <a:lnSpc>
                <a:spcPct val="100000"/>
              </a:lnSpc>
              <a:buNone/>
              <a:defRPr lang="en-US" sz="839" b="0" strike="noStrike" spc="-1">
                <a:solidFill>
                  <a:srgbClr val="8B8B8B"/>
                </a:solidFill>
                <a:latin typeface="Calibri"/>
              </a:defRPr>
            </a:lvl1pPr>
          </a:lstStyle>
          <a:p>
            <a:pPr>
              <a:lnSpc>
                <a:spcPct val="100000"/>
              </a:lnSpc>
              <a:buNone/>
            </a:pPr>
            <a:r>
              <a:rPr lang="en-US" sz="839" b="0" strike="noStrike" spc="-1">
                <a:solidFill>
                  <a:srgbClr val="8B8B8B"/>
                </a:solidFill>
                <a:latin typeface="Calibri"/>
              </a:rPr>
              <a:t>&lt;date/time&gt;</a:t>
            </a:r>
            <a:endParaRPr lang="en-US" sz="839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2"/>
          </p:nvPr>
        </p:nvSpPr>
        <p:spPr>
          <a:xfrm>
            <a:off x="2120400" y="7627680"/>
            <a:ext cx="2160000" cy="437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ctr">
              <a:buNone/>
              <a:defRPr lang="en-US" sz="1400" b="0" strike="noStrike" spc="-1">
                <a:latin typeface="Times New Roman"/>
              </a:defRPr>
            </a:lvl1pPr>
          </a:lstStyle>
          <a:p>
            <a:pPr algn="ctr">
              <a:buNone/>
            </a:pPr>
            <a:r>
              <a:rPr lang="en-US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sldNum" idx="3"/>
          </p:nvPr>
        </p:nvSpPr>
        <p:spPr>
          <a:xfrm>
            <a:off x="4520520" y="7627680"/>
            <a:ext cx="1440000" cy="437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r">
              <a:lnSpc>
                <a:spcPct val="100000"/>
              </a:lnSpc>
              <a:buNone/>
              <a:defRPr lang="en-US" sz="839" b="0" strike="noStrike" spc="-1">
                <a:solidFill>
                  <a:srgbClr val="8B8B8B"/>
                </a:solidFill>
                <a:latin typeface="Calibri"/>
              </a:defRPr>
            </a:lvl1pPr>
          </a:lstStyle>
          <a:p>
            <a:pPr algn="r">
              <a:lnSpc>
                <a:spcPct val="100000"/>
              </a:lnSpc>
              <a:buNone/>
            </a:pPr>
            <a:fld id="{AC288C3E-0F56-4B91-9B47-E0DD71A8CF3C}" type="slidenum">
              <a:rPr lang="en-US" sz="839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839" b="0" strike="noStrike" spc="-1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20040" y="1925640"/>
            <a:ext cx="5760360" cy="47725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lnSpc>
                <a:spcPct val="90000"/>
              </a:lnSpc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96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lnSpc>
                <a:spcPct val="90000"/>
              </a:lnSpc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26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lnSpc>
                <a:spcPct val="90000"/>
              </a:lnSpc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26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39920" y="438120"/>
            <a:ext cx="5520240" cy="1590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/>
          <a:p>
            <a:pPr>
              <a:lnSpc>
                <a:spcPct val="90000"/>
              </a:lnSpc>
              <a:buNone/>
            </a:pPr>
            <a:r>
              <a:rPr lang="en-US" sz="3080" b="0" strike="noStrike" spc="-1">
                <a:solidFill>
                  <a:srgbClr val="000000"/>
                </a:solidFill>
                <a:latin typeface="Calibri Light"/>
              </a:rPr>
              <a:t>Click to edit Master title style</a:t>
            </a:r>
            <a:endParaRPr lang="en-US" sz="308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39920" y="2190600"/>
            <a:ext cx="5520240" cy="5221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160200" indent="-160200">
              <a:lnSpc>
                <a:spcPct val="9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</a:pPr>
            <a:r>
              <a:rPr lang="en-US" sz="1960" b="0" strike="noStrike" spc="-1">
                <a:solidFill>
                  <a:srgbClr val="000000"/>
                </a:solidFill>
                <a:latin typeface="Calibri"/>
              </a:rPr>
              <a:t>Edit Master text styles</a:t>
            </a:r>
          </a:p>
          <a:p>
            <a:pPr marL="480240" lvl="1" indent="-160200">
              <a:lnSpc>
                <a:spcPct val="90000"/>
              </a:lnSpc>
              <a:spcBef>
                <a:spcPts val="349"/>
              </a:spcBef>
              <a:buClr>
                <a:srgbClr val="000000"/>
              </a:buClr>
              <a:buFont typeface="Arial"/>
              <a:buChar char="•"/>
            </a:pPr>
            <a:r>
              <a:rPr lang="en-US" sz="1679" b="0" strike="noStrike" spc="-1">
                <a:solidFill>
                  <a:srgbClr val="000000"/>
                </a:solidFill>
                <a:latin typeface="Calibri"/>
              </a:rPr>
              <a:t>Second level</a:t>
            </a:r>
          </a:p>
          <a:p>
            <a:pPr marL="800280" lvl="2" indent="-160200">
              <a:lnSpc>
                <a:spcPct val="90000"/>
              </a:lnSpc>
              <a:spcBef>
                <a:spcPts val="349"/>
              </a:spcBef>
              <a:buClr>
                <a:srgbClr val="000000"/>
              </a:buClr>
              <a:buFont typeface="Arial"/>
              <a:buChar char="•"/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</a:rPr>
              <a:t>Third level</a:t>
            </a:r>
          </a:p>
          <a:p>
            <a:pPr marL="1120320" lvl="3" indent="-160200">
              <a:lnSpc>
                <a:spcPct val="90000"/>
              </a:lnSpc>
              <a:spcBef>
                <a:spcPts val="349"/>
              </a:spcBef>
              <a:buClr>
                <a:srgbClr val="000000"/>
              </a:buClr>
              <a:buFont typeface="Arial"/>
              <a:buChar char="•"/>
            </a:pPr>
            <a:r>
              <a:rPr lang="en-US" sz="1260" b="0" strike="noStrike" spc="-1">
                <a:solidFill>
                  <a:srgbClr val="000000"/>
                </a:solidFill>
                <a:latin typeface="Calibri"/>
              </a:rPr>
              <a:t>Fourth level</a:t>
            </a:r>
          </a:p>
          <a:p>
            <a:pPr marL="1440360" lvl="4" indent="-160200">
              <a:lnSpc>
                <a:spcPct val="90000"/>
              </a:lnSpc>
              <a:spcBef>
                <a:spcPts val="349"/>
              </a:spcBef>
              <a:buClr>
                <a:srgbClr val="000000"/>
              </a:buClr>
              <a:buFont typeface="Arial"/>
              <a:buChar char="•"/>
            </a:pPr>
            <a:r>
              <a:rPr lang="en-US" sz="1260" b="0" strike="noStrike" spc="-1">
                <a:solidFill>
                  <a:srgbClr val="000000"/>
                </a:solidFill>
                <a:latin typeface="Calibri"/>
              </a:rPr>
              <a:t>Fifth level</a:t>
            </a: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39920" y="7627680"/>
            <a:ext cx="1440000" cy="437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>
              <a:lnSpc>
                <a:spcPct val="100000"/>
              </a:lnSpc>
              <a:buNone/>
              <a:defRPr lang="en-US" sz="839" b="0" strike="noStrike" spc="-1">
                <a:solidFill>
                  <a:srgbClr val="8B8B8B"/>
                </a:solidFill>
                <a:latin typeface="Calibri"/>
              </a:defRPr>
            </a:lvl1pPr>
          </a:lstStyle>
          <a:p>
            <a:pPr>
              <a:lnSpc>
                <a:spcPct val="100000"/>
              </a:lnSpc>
              <a:buNone/>
            </a:pPr>
            <a:r>
              <a:rPr lang="en-US" sz="839" b="0" strike="noStrike" spc="-1">
                <a:solidFill>
                  <a:srgbClr val="8B8B8B"/>
                </a:solidFill>
                <a:latin typeface="Calibri"/>
              </a:rPr>
              <a:t>&lt;date/time&gt;</a:t>
            </a:r>
            <a:endParaRPr lang="en-US" sz="839" b="0" strike="noStrike" spc="-1"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120400" y="7627680"/>
            <a:ext cx="2160000" cy="437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ctr">
              <a:buNone/>
              <a:defRPr lang="en-US" sz="1400" b="0" strike="noStrike" spc="-1">
                <a:latin typeface="Times New Roman"/>
              </a:defRPr>
            </a:lvl1pPr>
          </a:lstStyle>
          <a:p>
            <a:pPr algn="ctr">
              <a:buNone/>
            </a:pPr>
            <a:r>
              <a:rPr lang="en-US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520520" y="7627680"/>
            <a:ext cx="1440000" cy="437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r">
              <a:lnSpc>
                <a:spcPct val="100000"/>
              </a:lnSpc>
              <a:buNone/>
              <a:defRPr lang="en-US" sz="839" b="0" strike="noStrike" spc="-1">
                <a:solidFill>
                  <a:srgbClr val="8B8B8B"/>
                </a:solidFill>
                <a:latin typeface="Calibri"/>
              </a:defRPr>
            </a:lvl1pPr>
          </a:lstStyle>
          <a:p>
            <a:pPr algn="r">
              <a:lnSpc>
                <a:spcPct val="100000"/>
              </a:lnSpc>
              <a:buNone/>
            </a:pPr>
            <a:fld id="{3CB932E4-6183-4C3C-83B2-084B125CBD6E}" type="slidenum">
              <a:rPr lang="en-US" sz="839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839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7" Type="http://schemas.openxmlformats.org/officeDocument/2006/relationships/image" Target="../media/image17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1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1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14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">
            <a:extLst>
              <a:ext uri="{FF2B5EF4-FFF2-40B4-BE49-F238E27FC236}">
                <a16:creationId xmlns:a16="http://schemas.microsoft.com/office/drawing/2014/main" id="{93D8D44B-AECA-4BFC-823C-A04EB2E298C4}"/>
              </a:ext>
            </a:extLst>
          </p:cNvPr>
          <p:cNvSpPr txBox="1"/>
          <p:nvPr/>
        </p:nvSpPr>
        <p:spPr>
          <a:xfrm>
            <a:off x="6600" y="0"/>
            <a:ext cx="2877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6677A1AA-FD48-4EF5-86E1-2C2736AB1CB7}"/>
              </a:ext>
            </a:extLst>
          </p:cNvPr>
          <p:cNvSpPr txBox="1">
            <a:spLocks/>
          </p:cNvSpPr>
          <p:nvPr/>
        </p:nvSpPr>
        <p:spPr>
          <a:xfrm>
            <a:off x="369869" y="2630191"/>
            <a:ext cx="5712521" cy="2023999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</a:t>
            </a:r>
            <a:r>
              <a:rPr lang="vi-V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volume in STINGel treated and control group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volume of mice treated wit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NGe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lue line) in comparison to vehicle (black line) in orthotopic MOC1 oral tumor model, based on the groups performed by Leach et al. (). Arrow indicate time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NGe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MDP (vehicle) injection. The dots show the mean values; the error bars indicate the standard error of mean. n = 10-12 per group. Two-way ANOVA were used, 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. 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30A096F-E598-4B2F-9888-3C41A7FE61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4764486"/>
              </p:ext>
            </p:extLst>
          </p:nvPr>
        </p:nvGraphicFramePr>
        <p:xfrm>
          <a:off x="318410" y="468016"/>
          <a:ext cx="2606675" cy="2162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607022" imgH="2162803" progId="Prism9.Document">
                  <p:embed/>
                </p:oleObj>
              </mc:Choice>
              <mc:Fallback>
                <p:oleObj name="Prism 9" r:id="rId2" imgW="2607022" imgH="2162803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2FFC163-55B9-4F7A-A2C8-70538EC974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8410" y="468016"/>
                        <a:ext cx="2606675" cy="2162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01074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Picture 107">
            <a:extLst>
              <a:ext uri="{FF2B5EF4-FFF2-40B4-BE49-F238E27FC236}">
                <a16:creationId xmlns:a16="http://schemas.microsoft.com/office/drawing/2014/main" id="{E6DC25E0-D1FD-481A-9DD6-D9AED793854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943" y="6786769"/>
            <a:ext cx="1828800" cy="137160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491D79DE-5986-4ED7-9B22-D311B13135A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0" y="263586"/>
            <a:ext cx="3566160" cy="2103120"/>
          </a:xfrm>
          <a:prstGeom prst="rect">
            <a:avLst/>
          </a:prstGeom>
        </p:spPr>
      </p:pic>
      <p:sp>
        <p:nvSpPr>
          <p:cNvPr id="12" name="TextBox 2">
            <a:extLst>
              <a:ext uri="{FF2B5EF4-FFF2-40B4-BE49-F238E27FC236}">
                <a16:creationId xmlns:a16="http://schemas.microsoft.com/office/drawing/2014/main" id="{8218A88D-3A13-4E85-9969-6E7812D9A15B}"/>
              </a:ext>
            </a:extLst>
          </p:cNvPr>
          <p:cNvSpPr txBox="1"/>
          <p:nvPr/>
        </p:nvSpPr>
        <p:spPr>
          <a:xfrm>
            <a:off x="6600" y="1"/>
            <a:ext cx="2984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73B6EC9-712D-47EE-BDC0-7C4F0082BBF9}"/>
              </a:ext>
            </a:extLst>
          </p:cNvPr>
          <p:cNvCxnSpPr>
            <a:cxnSpLocks/>
          </p:cNvCxnSpPr>
          <p:nvPr/>
        </p:nvCxnSpPr>
        <p:spPr>
          <a:xfrm flipV="1">
            <a:off x="572600" y="7456915"/>
            <a:ext cx="0" cy="59436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3C24BC78-AA53-4F9D-865D-1598C0416863}"/>
              </a:ext>
            </a:extLst>
          </p:cNvPr>
          <p:cNvCxnSpPr>
            <a:cxnSpLocks/>
          </p:cNvCxnSpPr>
          <p:nvPr/>
        </p:nvCxnSpPr>
        <p:spPr>
          <a:xfrm>
            <a:off x="566294" y="8043174"/>
            <a:ext cx="591399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907ECE4-D723-4060-9689-690E6E3A47CE}"/>
              </a:ext>
            </a:extLst>
          </p:cNvPr>
          <p:cNvSpPr txBox="1"/>
          <p:nvPr/>
        </p:nvSpPr>
        <p:spPr>
          <a:xfrm rot="16200000">
            <a:off x="191596" y="7651489"/>
            <a:ext cx="611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UMAP 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3D176B-AF70-49F0-BFDF-078378C8F00F}"/>
              </a:ext>
            </a:extLst>
          </p:cNvPr>
          <p:cNvSpPr txBox="1"/>
          <p:nvPr/>
        </p:nvSpPr>
        <p:spPr>
          <a:xfrm>
            <a:off x="543017" y="8019271"/>
            <a:ext cx="6178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UMAP 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F461420-1799-4BE5-9440-81F5238A8774}"/>
              </a:ext>
            </a:extLst>
          </p:cNvPr>
          <p:cNvSpPr txBox="1"/>
          <p:nvPr/>
        </p:nvSpPr>
        <p:spPr>
          <a:xfrm>
            <a:off x="5770250" y="994284"/>
            <a:ext cx="51540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9651CD7-022C-4858-B576-F966F690E8AD}"/>
              </a:ext>
            </a:extLst>
          </p:cNvPr>
          <p:cNvSpPr txBox="1"/>
          <p:nvPr/>
        </p:nvSpPr>
        <p:spPr>
          <a:xfrm>
            <a:off x="5771606" y="1139167"/>
            <a:ext cx="62983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STINGe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1063952D-9881-4061-A7E3-30A32133C72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80" y="282568"/>
            <a:ext cx="2926080" cy="210312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79C791CB-2083-45D6-8084-1FBF65F6A80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431" y="2328779"/>
            <a:ext cx="5029200" cy="2103120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EACBC989-6C5E-4758-B172-478DB0F66C2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943" y="4305295"/>
            <a:ext cx="1828800" cy="1371600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23D864B5-A98E-4918-9A77-58AF9A70DC19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4558" y="4305295"/>
            <a:ext cx="1828800" cy="1371600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04E9C1BE-5BAF-42F6-ADEF-E177972603DD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488" y="4305295"/>
            <a:ext cx="1828800" cy="1371600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E8BF30BC-B733-46EF-A052-DD002D507D24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758" y="5562306"/>
            <a:ext cx="1828800" cy="1371600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D3BFF067-54D4-4266-BE31-6C75E337A795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4558" y="5562267"/>
            <a:ext cx="1828800" cy="1371600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B19CEB66-97CF-4C3C-8358-47D7D5EC1646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488" y="5562267"/>
            <a:ext cx="1828800" cy="13716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091D5BF-EBCC-4F35-9E3B-3EA4B1D8C7EC}"/>
              </a:ext>
            </a:extLst>
          </p:cNvPr>
          <p:cNvSpPr txBox="1"/>
          <p:nvPr/>
        </p:nvSpPr>
        <p:spPr>
          <a:xfrm>
            <a:off x="-5928" y="243294"/>
            <a:ext cx="396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A8CC9D3-1CB7-41CD-86C4-AF6797390B65}"/>
              </a:ext>
            </a:extLst>
          </p:cNvPr>
          <p:cNvSpPr txBox="1"/>
          <p:nvPr/>
        </p:nvSpPr>
        <p:spPr>
          <a:xfrm>
            <a:off x="-5928" y="2271073"/>
            <a:ext cx="396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737EBDC-C267-4829-90E9-B5615E5BA269}"/>
              </a:ext>
            </a:extLst>
          </p:cNvPr>
          <p:cNvSpPr txBox="1"/>
          <p:nvPr/>
        </p:nvSpPr>
        <p:spPr>
          <a:xfrm>
            <a:off x="-5928" y="4244421"/>
            <a:ext cx="396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AC7AF257-4234-43CE-BB0D-96BC8A1CDC37}"/>
              </a:ext>
            </a:extLst>
          </p:cNvPr>
          <p:cNvSpPr>
            <a:spLocks noGrp="1"/>
          </p:cNvSpPr>
          <p:nvPr>
            <p:ph type="subTitle"/>
          </p:nvPr>
        </p:nvSpPr>
        <p:spPr>
          <a:xfrm>
            <a:off x="380144" y="308224"/>
            <a:ext cx="5756134" cy="2578813"/>
          </a:xfrm>
        </p:spPr>
        <p:txBody>
          <a:bodyPr/>
          <a:lstStyle/>
          <a:p>
            <a:pPr marL="0" indent="0" algn="just">
              <a:lnSpc>
                <a:spcPct val="150000"/>
              </a:lnSpc>
              <a:buNone/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Single cell RNA sequencing analysis of oral squamous cell carcinoma model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form manifold approximation and projection (UMAP) of single cell RNA sequencing data separated by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lusters (left panel) and treatment method (right panel)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ot plot of average expression of the canonical markers of each cell-type. The relative gene expression in percent is represented by size of dots. The average expression level is indicated by the color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eature plot showed the expression of marker genes of each cluster.</a:t>
            </a:r>
          </a:p>
        </p:txBody>
      </p:sp>
    </p:spTree>
    <p:extLst>
      <p:ext uri="{BB962C8B-B14F-4D97-AF65-F5344CB8AC3E}">
        <p14:creationId xmlns:p14="http://schemas.microsoft.com/office/powerpoint/2010/main" val="27208633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A90BBA8-C3A0-43C6-BE37-E90BFDEA818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192" y="1641958"/>
            <a:ext cx="1828800" cy="1371600"/>
          </a:xfrm>
          <a:prstGeom prst="rect">
            <a:avLst/>
          </a:prstGeom>
        </p:spPr>
      </p:pic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1EAAD663-267A-4454-87BB-E5192F2745A0}"/>
              </a:ext>
            </a:extLst>
          </p:cNvPr>
          <p:cNvCxnSpPr>
            <a:cxnSpLocks/>
          </p:cNvCxnSpPr>
          <p:nvPr/>
        </p:nvCxnSpPr>
        <p:spPr>
          <a:xfrm flipV="1">
            <a:off x="347251" y="2396019"/>
            <a:ext cx="0" cy="59436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1011DC3E-550C-4A38-9A08-F14A538BBA27}"/>
              </a:ext>
            </a:extLst>
          </p:cNvPr>
          <p:cNvCxnSpPr>
            <a:cxnSpLocks/>
          </p:cNvCxnSpPr>
          <p:nvPr/>
        </p:nvCxnSpPr>
        <p:spPr>
          <a:xfrm>
            <a:off x="340945" y="2982278"/>
            <a:ext cx="591399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B3CB6ED5-38AB-4291-85CB-383F0BA9B300}"/>
              </a:ext>
            </a:extLst>
          </p:cNvPr>
          <p:cNvSpPr txBox="1"/>
          <p:nvPr/>
        </p:nvSpPr>
        <p:spPr>
          <a:xfrm rot="16200000">
            <a:off x="-33753" y="2582899"/>
            <a:ext cx="6115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MAP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A167A8-7DA0-48E8-84D2-49D03B8A02C4}"/>
              </a:ext>
            </a:extLst>
          </p:cNvPr>
          <p:cNvSpPr txBox="1"/>
          <p:nvPr/>
        </p:nvSpPr>
        <p:spPr>
          <a:xfrm>
            <a:off x="317668" y="2958375"/>
            <a:ext cx="6178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MAP 1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80AD5CD-0040-4667-8BA9-0E7585F6869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192" y="299813"/>
            <a:ext cx="1828800" cy="13716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2576501-B47F-4ECA-A0C9-2FC5EA1BC16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3632" y="299813"/>
            <a:ext cx="1828800" cy="13716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252B4CF-2F4C-4181-A69B-0A383B461F2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8231" y="1641958"/>
            <a:ext cx="1828800" cy="13716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84DB843-A31E-439A-9D36-5D1F1B69781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8231" y="299813"/>
            <a:ext cx="1828800" cy="13716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22B9A68-2A74-4448-87DD-BBEFDD0C933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3632" y="1641958"/>
            <a:ext cx="1828800" cy="1371600"/>
          </a:xfrm>
          <a:prstGeom prst="rect">
            <a:avLst/>
          </a:prstGeom>
        </p:spPr>
      </p:pic>
      <p:sp>
        <p:nvSpPr>
          <p:cNvPr id="15" name="TextBox 2">
            <a:extLst>
              <a:ext uri="{FF2B5EF4-FFF2-40B4-BE49-F238E27FC236}">
                <a16:creationId xmlns:a16="http://schemas.microsoft.com/office/drawing/2014/main" id="{1B322C45-3D52-491D-B0EC-9D20D48AA7C4}"/>
              </a:ext>
            </a:extLst>
          </p:cNvPr>
          <p:cNvSpPr txBox="1"/>
          <p:nvPr/>
        </p:nvSpPr>
        <p:spPr>
          <a:xfrm>
            <a:off x="6600" y="1"/>
            <a:ext cx="2984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A4C5A0DD-C78D-4393-85A0-90C9326E6AAD}"/>
              </a:ext>
            </a:extLst>
          </p:cNvPr>
          <p:cNvSpPr>
            <a:spLocks noGrp="1"/>
          </p:cNvSpPr>
          <p:nvPr>
            <p:ph type="subTitle"/>
          </p:nvPr>
        </p:nvSpPr>
        <p:spPr>
          <a:xfrm>
            <a:off x="424546" y="3463910"/>
            <a:ext cx="5762060" cy="993790"/>
          </a:xfrm>
        </p:spPr>
        <p:txBody>
          <a:bodyPr/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: Identified makers for sub-clusters of macrophages and neutrophil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ature plot showed the expression of marker genes of each cluster on UMAP.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98656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2">
            <a:extLst>
              <a:ext uri="{FF2B5EF4-FFF2-40B4-BE49-F238E27FC236}">
                <a16:creationId xmlns:a16="http://schemas.microsoft.com/office/drawing/2014/main" id="{47FD9743-B6E9-41EF-9423-6743DADF9DF7}"/>
              </a:ext>
            </a:extLst>
          </p:cNvPr>
          <p:cNvSpPr txBox="1"/>
          <p:nvPr/>
        </p:nvSpPr>
        <p:spPr>
          <a:xfrm>
            <a:off x="6600" y="0"/>
            <a:ext cx="287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E994E5E-2F6D-4A3C-AA68-800BD2D04FD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3800" y="301165"/>
            <a:ext cx="3200400" cy="6400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44AD4AF-C744-4DB9-A8FE-5D9E8812EB3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00" y="301165"/>
            <a:ext cx="3200400" cy="6400800"/>
          </a:xfrm>
          <a:prstGeom prst="rect">
            <a:avLst/>
          </a:prstGeom>
        </p:spPr>
      </p:pic>
      <p:sp>
        <p:nvSpPr>
          <p:cNvPr id="12" name="Subtitle 2">
            <a:extLst>
              <a:ext uri="{FF2B5EF4-FFF2-40B4-BE49-F238E27FC236}">
                <a16:creationId xmlns:a16="http://schemas.microsoft.com/office/drawing/2014/main" id="{58B9750D-0F96-42DE-A3FD-AFD47DD67FB5}"/>
              </a:ext>
            </a:extLst>
          </p:cNvPr>
          <p:cNvSpPr>
            <a:spLocks noGrp="1"/>
          </p:cNvSpPr>
          <p:nvPr>
            <p:ph type="subTitle"/>
          </p:nvPr>
        </p:nvSpPr>
        <p:spPr>
          <a:xfrm>
            <a:off x="359228" y="6718299"/>
            <a:ext cx="5760720" cy="1307199"/>
          </a:xfrm>
        </p:spPr>
        <p:txBody>
          <a:bodyPr/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: Enrichment analysis of Gene Ontology (GO) in M1-like macrophages and monocyte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of over-representation enrichment GO biological process pathways in M1-like macrophages (left panel) and monocytes (right panel).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40747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CB78A36D-1979-4107-B6EF-91FFF03B12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9809"/>
            <a:ext cx="3200400" cy="6400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8FE7290-5FF4-454E-935D-E2DEFA70175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0400" y="339809"/>
            <a:ext cx="3200400" cy="6400800"/>
          </a:xfrm>
          <a:prstGeom prst="rect">
            <a:avLst/>
          </a:prstGeom>
        </p:spPr>
      </p:pic>
      <p:sp>
        <p:nvSpPr>
          <p:cNvPr id="15" name="TextBox 2">
            <a:extLst>
              <a:ext uri="{FF2B5EF4-FFF2-40B4-BE49-F238E27FC236}">
                <a16:creationId xmlns:a16="http://schemas.microsoft.com/office/drawing/2014/main" id="{EF88684E-F461-4F43-8C2A-F1B804EEDAC5}"/>
              </a:ext>
            </a:extLst>
          </p:cNvPr>
          <p:cNvSpPr txBox="1"/>
          <p:nvPr/>
        </p:nvSpPr>
        <p:spPr>
          <a:xfrm>
            <a:off x="6600" y="0"/>
            <a:ext cx="287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 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1E3FCD45-F3DE-40C7-9A7A-9042E6A06383}"/>
              </a:ext>
            </a:extLst>
          </p:cNvPr>
          <p:cNvSpPr>
            <a:spLocks noGrp="1"/>
          </p:cNvSpPr>
          <p:nvPr>
            <p:ph type="subTitle"/>
          </p:nvPr>
        </p:nvSpPr>
        <p:spPr>
          <a:xfrm>
            <a:off x="369071" y="6765102"/>
            <a:ext cx="5760720" cy="1276721"/>
          </a:xfrm>
        </p:spPr>
        <p:txBody>
          <a:bodyPr/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: Enrichment analysis of Gene Ontology (GO) in N1-like and N2-like neutrophil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of over-representation enrichment GO biological process pathways in N1-like neutrophils (left panel) and N2-like neutrophils (right panel).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87064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2">
            <a:extLst>
              <a:ext uri="{FF2B5EF4-FFF2-40B4-BE49-F238E27FC236}">
                <a16:creationId xmlns:a16="http://schemas.microsoft.com/office/drawing/2014/main" id="{D0278446-5823-4F3A-92E9-B2631C523C65}"/>
              </a:ext>
            </a:extLst>
          </p:cNvPr>
          <p:cNvSpPr txBox="1"/>
          <p:nvPr/>
        </p:nvSpPr>
        <p:spPr>
          <a:xfrm>
            <a:off x="6600" y="0"/>
            <a:ext cx="287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C37941B-5387-4484-A6AD-E5353AC85E4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006" y="309788"/>
            <a:ext cx="5486400" cy="3200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D8006B0-F06E-4D18-BB31-ADF1939142C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3507067"/>
            <a:ext cx="5486400" cy="3200400"/>
          </a:xfrm>
          <a:prstGeom prst="rect">
            <a:avLst/>
          </a:prstGeom>
        </p:spPr>
      </p:pic>
      <p:sp>
        <p:nvSpPr>
          <p:cNvPr id="6" name="Subtitle 2">
            <a:extLst>
              <a:ext uri="{FF2B5EF4-FFF2-40B4-BE49-F238E27FC236}">
                <a16:creationId xmlns:a16="http://schemas.microsoft.com/office/drawing/2014/main" id="{C30EC721-100A-4CC7-A0E1-5C9B8757F10E}"/>
              </a:ext>
            </a:extLst>
          </p:cNvPr>
          <p:cNvSpPr>
            <a:spLocks noGrp="1"/>
          </p:cNvSpPr>
          <p:nvPr>
            <p:ph type="subTitle"/>
          </p:nvPr>
        </p:nvSpPr>
        <p:spPr>
          <a:xfrm>
            <a:off x="311921" y="6707467"/>
            <a:ext cx="5760720" cy="1383340"/>
          </a:xfrm>
        </p:spPr>
        <p:txBody>
          <a:bodyPr/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: Enrichment analysis of Gene Ontology (GO) in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nla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macrophages and PNS macrophage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of over-representation enrichment GO biological process pathways i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nl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macrophages (left panel) and PNS macrophages (right panel).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71871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">
            <a:extLst>
              <a:ext uri="{FF2B5EF4-FFF2-40B4-BE49-F238E27FC236}">
                <a16:creationId xmlns:a16="http://schemas.microsoft.com/office/drawing/2014/main" id="{9A070307-A634-4868-8445-2A031BF98F21}"/>
              </a:ext>
            </a:extLst>
          </p:cNvPr>
          <p:cNvSpPr txBox="1"/>
          <p:nvPr/>
        </p:nvSpPr>
        <p:spPr>
          <a:xfrm>
            <a:off x="6600" y="0"/>
            <a:ext cx="2877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39C8E72-05A5-48D1-BD19-2FCEE8E5DDB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28" t="32935" b="34183"/>
          <a:stretch/>
        </p:blipFill>
        <p:spPr>
          <a:xfrm>
            <a:off x="681901" y="4844186"/>
            <a:ext cx="4296281" cy="1524402"/>
          </a:xfrm>
          <a:prstGeom prst="rect">
            <a:avLst/>
          </a:prstGeom>
        </p:spPr>
      </p:pic>
      <p:grpSp>
        <p:nvGrpSpPr>
          <p:cNvPr id="18" name="Group 17">
            <a:extLst>
              <a:ext uri="{FF2B5EF4-FFF2-40B4-BE49-F238E27FC236}">
                <a16:creationId xmlns:a16="http://schemas.microsoft.com/office/drawing/2014/main" id="{1AE47418-1ED0-49FE-9BDF-75B3B65FA0BD}"/>
              </a:ext>
            </a:extLst>
          </p:cNvPr>
          <p:cNvGrpSpPr/>
          <p:nvPr/>
        </p:nvGrpSpPr>
        <p:grpSpPr>
          <a:xfrm>
            <a:off x="616449" y="528060"/>
            <a:ext cx="3200400" cy="2033998"/>
            <a:chOff x="616449" y="641074"/>
            <a:chExt cx="3200400" cy="203399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DC0AF2C-5AAC-49A7-9EFC-E0D2C58185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449" y="663392"/>
              <a:ext cx="3200400" cy="201168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590E82F-B9E7-4305-B09A-27E6E3D3FF75}"/>
                </a:ext>
              </a:extLst>
            </p:cNvPr>
            <p:cNvSpPr txBox="1"/>
            <p:nvPr/>
          </p:nvSpPr>
          <p:spPr>
            <a:xfrm>
              <a:off x="3165615" y="641074"/>
              <a:ext cx="46713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3.6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32F2B40-E3C9-41D5-88CE-6A0DDF2CF3F8}"/>
                </a:ext>
              </a:extLst>
            </p:cNvPr>
            <p:cNvSpPr txBox="1"/>
            <p:nvPr/>
          </p:nvSpPr>
          <p:spPr>
            <a:xfrm>
              <a:off x="2714596" y="1062168"/>
              <a:ext cx="4487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9.59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BF36037-8596-41C3-B3A7-88D1E3C033D7}"/>
                </a:ext>
              </a:extLst>
            </p:cNvPr>
            <p:cNvSpPr txBox="1"/>
            <p:nvPr/>
          </p:nvSpPr>
          <p:spPr>
            <a:xfrm>
              <a:off x="1707879" y="646044"/>
              <a:ext cx="458852" cy="21369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3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8401878-2BC4-4D22-9619-69AD6B6CBE21}"/>
                </a:ext>
              </a:extLst>
            </p:cNvPr>
            <p:cNvSpPr txBox="1"/>
            <p:nvPr/>
          </p:nvSpPr>
          <p:spPr>
            <a:xfrm>
              <a:off x="1232573" y="864257"/>
              <a:ext cx="47883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279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A84DB35-08F0-47E9-A6FC-DA9852786941}"/>
                </a:ext>
              </a:extLst>
            </p:cNvPr>
            <p:cNvSpPr txBox="1"/>
            <p:nvPr/>
          </p:nvSpPr>
          <p:spPr>
            <a:xfrm>
              <a:off x="1108213" y="2394792"/>
              <a:ext cx="51186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DAFE49C-CC3F-4D4D-A960-EC6E835A4F27}"/>
                </a:ext>
              </a:extLst>
            </p:cNvPr>
            <p:cNvSpPr txBox="1"/>
            <p:nvPr/>
          </p:nvSpPr>
          <p:spPr>
            <a:xfrm>
              <a:off x="1620078" y="2394792"/>
              <a:ext cx="62983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TINGel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161368B-DBA1-4BE9-A292-2E15D8A87590}"/>
                </a:ext>
              </a:extLst>
            </p:cNvPr>
            <p:cNvSpPr txBox="1"/>
            <p:nvPr/>
          </p:nvSpPr>
          <p:spPr>
            <a:xfrm>
              <a:off x="2664478" y="2394792"/>
              <a:ext cx="51186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AF38EF9-FD64-4C57-832A-0C0011B6D746}"/>
                </a:ext>
              </a:extLst>
            </p:cNvPr>
            <p:cNvSpPr txBox="1"/>
            <p:nvPr/>
          </p:nvSpPr>
          <p:spPr>
            <a:xfrm>
              <a:off x="3173661" y="2394792"/>
              <a:ext cx="62983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TINGel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290CF71F-2DF7-4C7C-8DA2-BA6F4F1D2FDF}"/>
              </a:ext>
            </a:extLst>
          </p:cNvPr>
          <p:cNvSpPr txBox="1"/>
          <p:nvPr/>
        </p:nvSpPr>
        <p:spPr>
          <a:xfrm>
            <a:off x="745963" y="4660577"/>
            <a:ext cx="213802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  <a:cs typeface="Arial" panose="020B0604020202020204" pitchFamily="34" charset="0"/>
              </a:rPr>
              <a:t>MIF signaling pathway in contro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6C7B351-3D41-4AEC-A6C9-C1B3D25F6A69}"/>
              </a:ext>
            </a:extLst>
          </p:cNvPr>
          <p:cNvSpPr txBox="1"/>
          <p:nvPr/>
        </p:nvSpPr>
        <p:spPr>
          <a:xfrm>
            <a:off x="3015861" y="4642858"/>
            <a:ext cx="22838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  <a:cs typeface="Arial" panose="020B0604020202020204" pitchFamily="34" charset="0"/>
              </a:rPr>
              <a:t>MIF signaling pathway in </a:t>
            </a:r>
            <a:r>
              <a:rPr lang="en-US" sz="800" dirty="0" err="1">
                <a:latin typeface="+mj-lt"/>
                <a:cs typeface="Arial" panose="020B0604020202020204" pitchFamily="34" charset="0"/>
              </a:rPr>
              <a:t>STINGel</a:t>
            </a:r>
            <a:r>
              <a:rPr lang="en-US" sz="800" dirty="0">
                <a:latin typeface="+mj-lt"/>
                <a:cs typeface="Arial" panose="020B0604020202020204" pitchFamily="34" charset="0"/>
              </a:rPr>
              <a:t> treatmen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BC59CA5-167A-48EE-AAE4-5A8EC3A6B477}"/>
              </a:ext>
            </a:extLst>
          </p:cNvPr>
          <p:cNvSpPr txBox="1"/>
          <p:nvPr/>
        </p:nvSpPr>
        <p:spPr>
          <a:xfrm>
            <a:off x="-5929" y="500149"/>
            <a:ext cx="447773" cy="3070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269C629-ACEE-49F5-927E-286CC79F6F25}"/>
              </a:ext>
            </a:extLst>
          </p:cNvPr>
          <p:cNvSpPr txBox="1"/>
          <p:nvPr/>
        </p:nvSpPr>
        <p:spPr>
          <a:xfrm>
            <a:off x="45499" y="2699001"/>
            <a:ext cx="396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0852DCB-8848-44D4-83F4-F9C68BE80119}"/>
              </a:ext>
            </a:extLst>
          </p:cNvPr>
          <p:cNvSpPr txBox="1"/>
          <p:nvPr/>
        </p:nvSpPr>
        <p:spPr>
          <a:xfrm>
            <a:off x="681901" y="2894334"/>
            <a:ext cx="213802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  <a:cs typeface="Arial" panose="020B0604020202020204" pitchFamily="34" charset="0"/>
              </a:rPr>
              <a:t>SPP1 signaling pathway in contro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0037A43-CFD5-4761-92B0-F8DA3455C09F}"/>
              </a:ext>
            </a:extLst>
          </p:cNvPr>
          <p:cNvSpPr txBox="1"/>
          <p:nvPr/>
        </p:nvSpPr>
        <p:spPr>
          <a:xfrm>
            <a:off x="2951799" y="2876615"/>
            <a:ext cx="22838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  <a:cs typeface="Arial" panose="020B0604020202020204" pitchFamily="34" charset="0"/>
              </a:rPr>
              <a:t>SPP1 signaling pathway in </a:t>
            </a:r>
            <a:r>
              <a:rPr lang="en-US" sz="800" dirty="0" err="1">
                <a:latin typeface="+mj-lt"/>
                <a:cs typeface="Arial" panose="020B0604020202020204" pitchFamily="34" charset="0"/>
              </a:rPr>
              <a:t>STINGel</a:t>
            </a:r>
            <a:r>
              <a:rPr lang="en-US" sz="800" dirty="0">
                <a:latin typeface="+mj-lt"/>
                <a:cs typeface="Arial" panose="020B0604020202020204" pitchFamily="34" charset="0"/>
              </a:rPr>
              <a:t> treatment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91421C11-B8A1-471A-B369-18C4CD6CC11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498" b="33319"/>
          <a:stretch/>
        </p:blipFill>
        <p:spPr>
          <a:xfrm>
            <a:off x="441844" y="6592710"/>
            <a:ext cx="4636008" cy="1584727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2CB2130F-245E-45E6-BFFD-69132F980C82}"/>
              </a:ext>
            </a:extLst>
          </p:cNvPr>
          <p:cNvSpPr txBox="1"/>
          <p:nvPr/>
        </p:nvSpPr>
        <p:spPr>
          <a:xfrm>
            <a:off x="751312" y="6403749"/>
            <a:ext cx="213802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  <a:cs typeface="Arial" panose="020B0604020202020204" pitchFamily="34" charset="0"/>
              </a:rPr>
              <a:t>TNF signaling pathway in 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5DF7B0D-5E64-4B76-9D29-BE84CAFCE7D6}"/>
              </a:ext>
            </a:extLst>
          </p:cNvPr>
          <p:cNvSpPr txBox="1"/>
          <p:nvPr/>
        </p:nvSpPr>
        <p:spPr>
          <a:xfrm>
            <a:off x="3021210" y="6386030"/>
            <a:ext cx="22838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  <a:cs typeface="Arial" panose="020B0604020202020204" pitchFamily="34" charset="0"/>
              </a:rPr>
              <a:t>TNF signaling pathway in </a:t>
            </a:r>
            <a:r>
              <a:rPr lang="en-US" sz="800" dirty="0" err="1">
                <a:latin typeface="+mj-lt"/>
                <a:cs typeface="Arial" panose="020B0604020202020204" pitchFamily="34" charset="0"/>
              </a:rPr>
              <a:t>STINGel</a:t>
            </a:r>
            <a:r>
              <a:rPr lang="en-US" sz="800" dirty="0">
                <a:latin typeface="+mj-lt"/>
                <a:cs typeface="Arial" panose="020B0604020202020204" pitchFamily="34" charset="0"/>
              </a:rPr>
              <a:t> treatmen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88D9544-1F02-4657-BDFA-BF1CBF854DF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4" t="33086" b="35593"/>
          <a:stretch/>
        </p:blipFill>
        <p:spPr>
          <a:xfrm>
            <a:off x="745962" y="3109500"/>
            <a:ext cx="4232490" cy="145204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2A0245A-3F64-4D58-A4F8-C8AB7BFAE4D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4" t="33086" b="35593"/>
          <a:stretch/>
        </p:blipFill>
        <p:spPr>
          <a:xfrm>
            <a:off x="745962" y="3099225"/>
            <a:ext cx="4232490" cy="1452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2065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>
            <a:extLst>
              <a:ext uri="{FF2B5EF4-FFF2-40B4-BE49-F238E27FC236}">
                <a16:creationId xmlns:a16="http://schemas.microsoft.com/office/drawing/2014/main" id="{282EF569-DAB0-471B-A171-68253B274808}"/>
              </a:ext>
            </a:extLst>
          </p:cNvPr>
          <p:cNvSpPr txBox="1">
            <a:spLocks/>
          </p:cNvSpPr>
          <p:nvPr/>
        </p:nvSpPr>
        <p:spPr>
          <a:xfrm>
            <a:off x="369869" y="143838"/>
            <a:ext cx="5712521" cy="2609636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7: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-cell communication in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NGel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and vehicle sample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verall number of interactions and signaling strength in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NGel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vehicle control quantified by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Cha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ircle plot of the significant ligand-receptor pairs for SPP1 (upper panel), MIF (middle panel) and TNF (lower panel) between each cell type i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NGe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and vehicle. Edge colors are consistent with the sources as sender, and edge weights are proportional to the interaction strength. Thicker edge line indicates a stronger signal.</a:t>
            </a:r>
          </a:p>
        </p:txBody>
      </p:sp>
    </p:spTree>
    <p:extLst>
      <p:ext uri="{BB962C8B-B14F-4D97-AF65-F5344CB8AC3E}">
        <p14:creationId xmlns:p14="http://schemas.microsoft.com/office/powerpoint/2010/main" val="3848957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70</TotalTime>
  <Words>524</Words>
  <Application>Microsoft Office PowerPoint</Application>
  <PresentationFormat>Custom</PresentationFormat>
  <Paragraphs>40</Paragraphs>
  <Slides>9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8" baseType="lpstr">
      <vt:lpstr>Arial</vt:lpstr>
      <vt:lpstr>Calibri</vt:lpstr>
      <vt:lpstr>Calibri Light</vt:lpstr>
      <vt:lpstr>Symbol</vt:lpstr>
      <vt:lpstr>Times New Roman</vt:lpstr>
      <vt:lpstr>Wingdings</vt:lpstr>
      <vt:lpstr>Office Theme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Dong, Minh Phuong</dc:creator>
  <dc:description/>
  <cp:lastModifiedBy>MDPI</cp:lastModifiedBy>
  <cp:revision>76</cp:revision>
  <dcterms:created xsi:type="dcterms:W3CDTF">2023-07-28T16:13:12Z</dcterms:created>
  <dcterms:modified xsi:type="dcterms:W3CDTF">2024-04-19T02:32:57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Custom</vt:lpwstr>
  </property>
  <property fmtid="{D5CDD505-2E9C-101B-9397-08002B2CF9AE}" pid="3" name="Slides">
    <vt:i4>8</vt:i4>
  </property>
</Properties>
</file>